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157"/>
    <p:restoredTop sz="96327"/>
  </p:normalViewPr>
  <p:slideViewPr>
    <p:cSldViewPr snapToGrid="0" snapToObjects="1">
      <p:cViewPr varScale="1">
        <p:scale>
          <a:sx n="120" d="100"/>
          <a:sy n="120" d="100"/>
        </p:scale>
        <p:origin x="18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E8DC35-5BCB-0948-9F26-42E0A44E95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11C9FF-F396-214E-9722-C6C5FEE4F11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CB5B64-DDE3-D342-9452-BAAFAA37AE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26867F-E3CA-E443-B062-CE35F0D06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CCE009-E798-CB43-9EF0-659245A1BE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158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9C93C7-353F-6D4E-8370-6C5C2656A1E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5F26788-2D6E-C647-8E19-C73A5658B2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F1575F-FA23-554A-992C-4ADE331F64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B348EDB-CECD-CA4E-BA53-07285C762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4012AAF-DA8C-3848-A2A2-1BAA47D2A9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91107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126DE35-3A58-B041-865B-E66AC10E3EB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C114255-1158-5C48-814B-27463316137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C533F66-AB5D-7F42-A991-F6C5658ED6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92EB20A-D504-C84E-99F9-FABF31B2B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E23E855-F713-EB43-8ED0-AFF4FF25B0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3807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8A44159-726B-5843-BDF1-C3D52CE2D4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EF41D5-608A-304A-A5EE-77739F8DC81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F28BA37-63CD-5144-B84A-0110930C88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BCCC7-016F-2F4B-8C63-050C86D929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140369-598B-3749-9946-BFA40CDF33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5448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C81783-2A99-FB48-944F-52BDC04F2D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DA83F9-197D-E74C-9A4E-D4BE21073CC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251AF-87A4-774F-9102-1E9648F683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FAFDAE-52F0-3841-AAB9-BB6585B858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409E39-6705-484E-B716-CEAD91E8AB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0201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38597A-5B0A-3C4F-B342-668E36835D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57F57AA-0F26-5B41-AA01-EC1A9589D9E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90EF449-D7CA-8B4C-851C-04362E72C7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0852C2-9D10-D840-BAF5-98301D5011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FBB34CF-5117-0545-81E6-15AC517F4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1A24353-B929-2E46-976A-FD0C21BDFB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88337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3C3F73-A131-254F-83FE-A63CA09E0E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FC37762-90A0-B44D-8896-0C03EE8BCD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A471B52-A177-A647-915B-98F38DA3870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81C73E4-459C-E74C-8A6E-ADF3816B22F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C8DA087-478E-CF41-81D4-57690B19DA0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5061A02-9FEF-6D43-A68A-DA066B68F3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FA941A6-A349-9D44-8476-83C8E03F3A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9D663E1-2A41-9E4F-A421-04BB9ABA0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369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6E9714-F663-A646-8E25-E783FCB9ECC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0D8ED23-31D0-804D-A04A-2D4405041D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D04BF97-9B8E-C441-86DE-D665E41CE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922D2D7-3B82-D346-937E-74AA54B94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57057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F667EAF-BB48-A84D-A00D-034F899DB1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833E917-5369-2E42-992C-4569E626B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D3536D5-7744-744C-A9BE-E7B98E64E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75525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6F5408-B05B-E749-BFE3-27D26C403B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F34FA41-2693-D345-962D-9F7120E0CBA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83CB8B1-7F42-504C-97DF-5766DB1B1B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5376C9B-D1DE-D54A-B91B-E4A18CA911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58EFA8A-E5D3-0648-BAA7-A25C060322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C0B0B8B-9BCC-894D-974F-8001B0F28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915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B6780B-E257-C943-B1C3-C99C11A1C6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58C8CE8-F263-3446-BF42-F788A77A70D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66C479E-122C-414B-A2F8-DA1C38AC47C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6618621-84C6-3E48-AEF1-34AF4E8506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BDF749-D137-8A40-898F-DBBE21A5E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663ABB6-38B8-5141-A4E8-538C90FA5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64879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D38ACC8-C3F0-B044-AA2B-134BC5C7CC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DB5CD64-CC63-A947-9DB8-8BCAA19D52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D31A59-E868-534A-B1E7-693C72A5CC4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1E5D32-FFCF-964C-B6C6-C71B54E96234}" type="datetimeFigureOut">
              <a:rPr lang="en-US" smtClean="0"/>
              <a:t>7/27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E35B10-EBB5-4C41-8619-3A89FAD1E0D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DE7F53-4F5F-1942-A5C2-6CCF73E7349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74A1A9-B28F-984B-A485-F71BA880C66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367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A451E61-DC52-7645-9F42-168F18B2FC28}"/>
              </a:ext>
            </a:extLst>
          </p:cNvPr>
          <p:cNvSpPr txBox="1"/>
          <p:nvPr/>
        </p:nvSpPr>
        <p:spPr>
          <a:xfrm>
            <a:off x="750627" y="368489"/>
            <a:ext cx="1044053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/>
              <a:t>Table 6. </a:t>
            </a:r>
            <a:r>
              <a:rPr lang="en-US" dirty="0"/>
              <a:t>Periodic and aperiodic vital signs measurements used in all trials where model input variables included vitals measurements.</a:t>
            </a:r>
          </a:p>
        </p:txBody>
      </p:sp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F844011A-B40B-5448-BD88-940D85358FD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50704544"/>
              </p:ext>
            </p:extLst>
          </p:nvPr>
        </p:nvGraphicFramePr>
        <p:xfrm>
          <a:off x="4372103" y="1014820"/>
          <a:ext cx="3447793" cy="5547360"/>
        </p:xfrm>
        <a:graphic>
          <a:graphicData uri="http://schemas.openxmlformats.org/drawingml/2006/table">
            <a:tbl>
              <a:tblPr firstRow="1" firstCol="1" bandRow="1">
                <a:tableStyleId>{7DF18680-E054-41AD-8BC1-D1AEF772440D}</a:tableStyleId>
              </a:tblPr>
              <a:tblGrid>
                <a:gridCol w="3447793">
                  <a:extLst>
                    <a:ext uri="{9D8B030D-6E8A-4147-A177-3AD203B41FA5}">
                      <a16:colId xmlns:a16="http://schemas.microsoft.com/office/drawing/2014/main" val="163907683"/>
                    </a:ext>
                  </a:extLst>
                </a:gridCol>
              </a:tblGrid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</a:rPr>
                        <a:t>Vital sign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extLst>
                  <a:ext uri="{0D108BD9-81ED-4DB2-BD59-A6C34878D82A}">
                    <a16:rowId xmlns:a16="http://schemas.microsoft.com/office/drawing/2014/main" val="3202982633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</a:rPr>
                        <a:t>Periodic measurement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3575341695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Temperat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3707422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Oxygen saturation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32533658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Heart rat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80031436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Respiratory rat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37138346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Central venous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8998265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End-tidal CO2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26470721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Systolic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1360419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Diastolic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3377774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Blood pressure mean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6687634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Pulmonary artery systolic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63920530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Pulmonary artery diastolic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2474624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Pulmonary artery mean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54495587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Intracranial pressur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3984481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</a:rPr>
                        <a:t>Aperiodic measurements</a:t>
                      </a:r>
                      <a:endParaRPr lang="en-US" sz="1400" b="1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</a:tcPr>
                </a:tc>
                <a:extLst>
                  <a:ext uri="{0D108BD9-81ED-4DB2-BD59-A6C34878D82A}">
                    <a16:rowId xmlns:a16="http://schemas.microsoft.com/office/drawing/2014/main" val="1381241443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Noninvasive systolic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1253404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Noninvasive diastolic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21656188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Noninvasive mean pressur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1689495"/>
                  </a:ext>
                </a:extLst>
              </a:tr>
              <a:tr h="60819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Pulmonary artery occlusion pressur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73580172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Cardiac output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92310262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Cardiac index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0085549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Systemic vascular resistance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7552062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Systemic vascular resistance index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52353978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>
                          <a:solidFill>
                            <a:schemeClr val="tx1"/>
                          </a:solidFill>
                          <a:effectLst/>
                        </a:rPr>
                        <a:t>Pulmonary vascular resistance</a:t>
                      </a:r>
                      <a:endParaRPr lang="en-US" sz="14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9233706"/>
                  </a:ext>
                </a:extLst>
              </a:tr>
              <a:tr h="185770">
                <a:tc>
                  <a:txBody>
                    <a:bodyPr/>
                    <a:lstStyle/>
                    <a:p>
                      <a:pPr marL="0" marR="0" algn="l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b="0" dirty="0">
                          <a:solidFill>
                            <a:schemeClr val="tx1"/>
                          </a:solidFill>
                          <a:effectLst/>
                        </a:rPr>
                        <a:t>Pulmonary vascular resistance index</a:t>
                      </a:r>
                      <a:endParaRPr lang="en-US" sz="14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8154561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568436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91</Words>
  <Application>Microsoft Macintosh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ssay, Patrick Thomas - (pessay)</dc:creator>
  <cp:lastModifiedBy>Essay, Patrick Thomas - (pessay)</cp:lastModifiedBy>
  <cp:revision>3</cp:revision>
  <dcterms:created xsi:type="dcterms:W3CDTF">2020-06-12T15:03:11Z</dcterms:created>
  <dcterms:modified xsi:type="dcterms:W3CDTF">2020-07-27T18:12:07Z</dcterms:modified>
</cp:coreProperties>
</file>